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81" d="100"/>
          <a:sy n="81" d="100"/>
        </p:scale>
        <p:origin x="3096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96DEC-4EF1-452B-AA35-ED478AF4CA15}" type="datetimeFigureOut">
              <a:rPr lang="en-IE" smtClean="0"/>
              <a:t>14/01/2017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DF4A6-56A4-4280-A3D4-9F8FA8AF0CCA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9452839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96DEC-4EF1-452B-AA35-ED478AF4CA15}" type="datetimeFigureOut">
              <a:rPr lang="en-IE" smtClean="0"/>
              <a:t>14/01/2017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DF4A6-56A4-4280-A3D4-9F8FA8AF0CCA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41050525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96DEC-4EF1-452B-AA35-ED478AF4CA15}" type="datetimeFigureOut">
              <a:rPr lang="en-IE" smtClean="0"/>
              <a:t>14/01/2017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DF4A6-56A4-4280-A3D4-9F8FA8AF0CCA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9281275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96DEC-4EF1-452B-AA35-ED478AF4CA15}" type="datetimeFigureOut">
              <a:rPr lang="en-IE" smtClean="0"/>
              <a:t>14/01/2017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DF4A6-56A4-4280-A3D4-9F8FA8AF0CCA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0125562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96DEC-4EF1-452B-AA35-ED478AF4CA15}" type="datetimeFigureOut">
              <a:rPr lang="en-IE" smtClean="0"/>
              <a:t>14/01/2017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DF4A6-56A4-4280-A3D4-9F8FA8AF0CCA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5242326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96DEC-4EF1-452B-AA35-ED478AF4CA15}" type="datetimeFigureOut">
              <a:rPr lang="en-IE" smtClean="0"/>
              <a:t>14/01/2017</a:t>
            </a:fld>
            <a:endParaRPr lang="en-I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DF4A6-56A4-4280-A3D4-9F8FA8AF0CCA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7595364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96DEC-4EF1-452B-AA35-ED478AF4CA15}" type="datetimeFigureOut">
              <a:rPr lang="en-IE" smtClean="0"/>
              <a:t>14/01/2017</a:t>
            </a:fld>
            <a:endParaRPr lang="en-I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DF4A6-56A4-4280-A3D4-9F8FA8AF0CCA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2789023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96DEC-4EF1-452B-AA35-ED478AF4CA15}" type="datetimeFigureOut">
              <a:rPr lang="en-IE" smtClean="0"/>
              <a:t>14/01/2017</a:t>
            </a:fld>
            <a:endParaRPr lang="en-I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DF4A6-56A4-4280-A3D4-9F8FA8AF0CCA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2199242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96DEC-4EF1-452B-AA35-ED478AF4CA15}" type="datetimeFigureOut">
              <a:rPr lang="en-IE" smtClean="0"/>
              <a:t>14/01/2017</a:t>
            </a:fld>
            <a:endParaRPr lang="en-I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DF4A6-56A4-4280-A3D4-9F8FA8AF0CCA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473609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96DEC-4EF1-452B-AA35-ED478AF4CA15}" type="datetimeFigureOut">
              <a:rPr lang="en-IE" smtClean="0"/>
              <a:t>14/01/2017</a:t>
            </a:fld>
            <a:endParaRPr lang="en-I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DF4A6-56A4-4280-A3D4-9F8FA8AF0CCA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9454443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96DEC-4EF1-452B-AA35-ED478AF4CA15}" type="datetimeFigureOut">
              <a:rPr lang="en-IE" smtClean="0"/>
              <a:t>14/01/2017</a:t>
            </a:fld>
            <a:endParaRPr lang="en-I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DF4A6-56A4-4280-A3D4-9F8FA8AF0CCA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7727746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996DEC-4EF1-452B-AA35-ED478AF4CA15}" type="datetimeFigureOut">
              <a:rPr lang="en-IE" smtClean="0"/>
              <a:t>14/01/2017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FDF4A6-56A4-4280-A3D4-9F8FA8AF0CCA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8911507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03427" y="1001672"/>
            <a:ext cx="2479419" cy="2030856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0" y="823249"/>
            <a:ext cx="259329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1400" b="1" dirty="0"/>
              <a:t>Amygdala</a:t>
            </a:r>
          </a:p>
          <a:p>
            <a:r>
              <a:rPr lang="en-IE" sz="1400" b="1" dirty="0"/>
              <a:t>Upregulated</a:t>
            </a: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398948" y="1001672"/>
            <a:ext cx="2221249" cy="2030856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3282846" y="801941"/>
            <a:ext cx="309297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1400" b="1" dirty="0"/>
              <a:t>Amygdala</a:t>
            </a:r>
          </a:p>
          <a:p>
            <a:r>
              <a:rPr lang="en-IE" sz="1400" b="1" dirty="0"/>
              <a:t>Downregulated</a:t>
            </a: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91018" y="3512297"/>
            <a:ext cx="2445174" cy="2200656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924785" y="3689280"/>
            <a:ext cx="2812112" cy="2050499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0" y="3250687"/>
            <a:ext cx="259329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1400" b="1" dirty="0"/>
              <a:t>Prefrontal Cortex</a:t>
            </a:r>
          </a:p>
          <a:p>
            <a:r>
              <a:rPr lang="en-IE" sz="1400" b="1" dirty="0"/>
              <a:t>Upregulated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2853166" y="3300168"/>
            <a:ext cx="155464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1400" b="1" dirty="0"/>
              <a:t>Prefrontal Cortex</a:t>
            </a:r>
          </a:p>
          <a:p>
            <a:r>
              <a:rPr lang="en-IE" sz="1400" b="1" dirty="0"/>
              <a:t>Downregulated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0" y="456924"/>
            <a:ext cx="254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1400" b="1" dirty="0" smtClean="0"/>
              <a:t>a</a:t>
            </a:r>
            <a:endParaRPr lang="en-IE" sz="1400" b="1" dirty="0"/>
          </a:p>
        </p:txBody>
      </p:sp>
      <p:sp>
        <p:nvSpPr>
          <p:cNvPr id="13" name="TextBox 12"/>
          <p:cNvSpPr txBox="1"/>
          <p:nvPr/>
        </p:nvSpPr>
        <p:spPr>
          <a:xfrm>
            <a:off x="3282846" y="435616"/>
            <a:ext cx="254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1400" b="1" dirty="0" smtClean="0"/>
              <a:t>b</a:t>
            </a:r>
            <a:endParaRPr lang="en-IE" sz="1400" b="1" dirty="0"/>
          </a:p>
        </p:txBody>
      </p:sp>
      <p:sp>
        <p:nvSpPr>
          <p:cNvPr id="14" name="TextBox 13"/>
          <p:cNvSpPr txBox="1"/>
          <p:nvPr/>
        </p:nvSpPr>
        <p:spPr>
          <a:xfrm>
            <a:off x="0" y="2969215"/>
            <a:ext cx="254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1400" b="1" dirty="0" smtClean="0"/>
              <a:t>c</a:t>
            </a:r>
            <a:endParaRPr lang="en-IE" sz="1400" b="1" dirty="0"/>
          </a:p>
        </p:txBody>
      </p:sp>
      <p:sp>
        <p:nvSpPr>
          <p:cNvPr id="15" name="TextBox 14"/>
          <p:cNvSpPr txBox="1"/>
          <p:nvPr/>
        </p:nvSpPr>
        <p:spPr>
          <a:xfrm>
            <a:off x="3282846" y="2947907"/>
            <a:ext cx="254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1400" b="1" dirty="0" smtClean="0"/>
              <a:t>d</a:t>
            </a:r>
            <a:endParaRPr lang="en-IE" sz="1400" b="1" dirty="0"/>
          </a:p>
        </p:txBody>
      </p:sp>
      <p:sp>
        <p:nvSpPr>
          <p:cNvPr id="16" name="TextBox 15"/>
          <p:cNvSpPr txBox="1"/>
          <p:nvPr/>
        </p:nvSpPr>
        <p:spPr>
          <a:xfrm>
            <a:off x="31854" y="1864227"/>
            <a:ext cx="120962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900" b="1" dirty="0">
                <a:solidFill>
                  <a:srgbClr val="FF0000"/>
                </a:solidFill>
              </a:rPr>
              <a:t>miR-32-3p</a:t>
            </a:r>
          </a:p>
          <a:p>
            <a:r>
              <a:rPr lang="en-IE" sz="900" b="1" dirty="0">
                <a:solidFill>
                  <a:srgbClr val="FF0000"/>
                </a:solidFill>
              </a:rPr>
              <a:t>Further increased by </a:t>
            </a:r>
            <a:r>
              <a:rPr lang="en-IE" sz="1000" b="1" dirty="0">
                <a:solidFill>
                  <a:srgbClr val="FF0000"/>
                </a:solidFill>
              </a:rPr>
              <a:t>colonization</a:t>
            </a:r>
            <a:endParaRPr lang="en-IE" sz="900" b="1" dirty="0">
              <a:solidFill>
                <a:srgbClr val="FF0000"/>
              </a:solidFill>
            </a:endParaRPr>
          </a:p>
        </p:txBody>
      </p:sp>
      <p:sp>
        <p:nvSpPr>
          <p:cNvPr id="17" name="Oval 16"/>
          <p:cNvSpPr/>
          <p:nvPr/>
        </p:nvSpPr>
        <p:spPr>
          <a:xfrm>
            <a:off x="2171700" y="2025650"/>
            <a:ext cx="190500" cy="147340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E"/>
          </a:p>
        </p:txBody>
      </p:sp>
      <p:sp>
        <p:nvSpPr>
          <p:cNvPr id="18" name="TextBox 60"/>
          <p:cNvSpPr txBox="1"/>
          <p:nvPr/>
        </p:nvSpPr>
        <p:spPr>
          <a:xfrm>
            <a:off x="-42039" y="-31725"/>
            <a:ext cx="163377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900" b="1"/>
              <a:t>Supplemental Figure 1</a:t>
            </a:r>
            <a:endParaRPr lang="en-IE" sz="900" b="1" dirty="0"/>
          </a:p>
        </p:txBody>
      </p:sp>
    </p:spTree>
    <p:extLst>
      <p:ext uri="{BB962C8B-B14F-4D97-AF65-F5344CB8AC3E}">
        <p14:creationId xmlns:p14="http://schemas.microsoft.com/office/powerpoint/2010/main" val="26434519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22</Words>
  <Application>Microsoft Office PowerPoint</Application>
  <PresentationFormat>A4 Paper (210x297 mm)</PresentationFormat>
  <Paragraphs>1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Hewlett-Packar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an</dc:creator>
  <cp:lastModifiedBy>Hoban, Alan</cp:lastModifiedBy>
  <cp:revision>3</cp:revision>
  <dcterms:created xsi:type="dcterms:W3CDTF">2016-09-14T11:48:04Z</dcterms:created>
  <dcterms:modified xsi:type="dcterms:W3CDTF">2017-01-14T12:55:12Z</dcterms:modified>
</cp:coreProperties>
</file>